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336" y="-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1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s7hcs-2.bmp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763688" y="1196752"/>
            <a:ext cx="4368800" cy="3505200"/>
          </a:xfrm>
          <a:prstGeom prst="rect">
            <a:avLst/>
          </a:prstGeom>
        </p:spPr>
      </p:pic>
      <p:sp>
        <p:nvSpPr>
          <p:cNvPr id="6" name="矩形 5"/>
          <p:cNvSpPr/>
          <p:nvPr/>
        </p:nvSpPr>
        <p:spPr>
          <a:xfrm>
            <a:off x="2915816" y="1556792"/>
            <a:ext cx="2664296" cy="273630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TextBox 25"/>
          <p:cNvSpPr txBox="1"/>
          <p:nvPr/>
        </p:nvSpPr>
        <p:spPr>
          <a:xfrm>
            <a:off x="2024666" y="2031921"/>
            <a:ext cx="86356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nLUC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r"/>
            <a:r>
              <a:rPr lang="en-US" altLang="zh-CN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cLUC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26"/>
          <p:cNvSpPr txBox="1"/>
          <p:nvPr/>
        </p:nvSpPr>
        <p:spPr>
          <a:xfrm>
            <a:off x="1376067" y="3030957"/>
            <a:ext cx="151216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nLUC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zh-CN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cLUC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altLang="zh-CN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ZmGDI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</a:p>
        </p:txBody>
      </p:sp>
      <p:sp>
        <p:nvSpPr>
          <p:cNvPr id="9" name="TextBox 27"/>
          <p:cNvSpPr txBox="1"/>
          <p:nvPr/>
        </p:nvSpPr>
        <p:spPr>
          <a:xfrm>
            <a:off x="6060293" y="3030957"/>
            <a:ext cx="142515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P7-1-nLUC</a:t>
            </a:r>
          </a:p>
          <a:p>
            <a:r>
              <a:rPr lang="en-US" altLang="zh-CN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cLUC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r>
              <a:rPr lang="en-US" altLang="zh-CN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ZmGDI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</a:p>
        </p:txBody>
      </p:sp>
      <p:sp>
        <p:nvSpPr>
          <p:cNvPr id="10" name="TextBox 28"/>
          <p:cNvSpPr txBox="1"/>
          <p:nvPr/>
        </p:nvSpPr>
        <p:spPr>
          <a:xfrm>
            <a:off x="6060293" y="2031921"/>
            <a:ext cx="122413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P7-1-nLUC</a:t>
            </a:r>
          </a:p>
          <a:p>
            <a:r>
              <a:rPr lang="en-US" altLang="zh-CN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cLUC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椭圆 10"/>
          <p:cNvSpPr/>
          <p:nvPr/>
        </p:nvSpPr>
        <p:spPr>
          <a:xfrm rot="1753652" flipV="1">
            <a:off x="3618079" y="2275788"/>
            <a:ext cx="560710" cy="586983"/>
          </a:xfrm>
          <a:prstGeom prst="ellipse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椭圆 11"/>
          <p:cNvSpPr/>
          <p:nvPr/>
        </p:nvSpPr>
        <p:spPr>
          <a:xfrm rot="1753652" flipV="1">
            <a:off x="3583392" y="3042896"/>
            <a:ext cx="560710" cy="586983"/>
          </a:xfrm>
          <a:prstGeom prst="ellipse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椭圆 12"/>
          <p:cNvSpPr/>
          <p:nvPr/>
        </p:nvSpPr>
        <p:spPr>
          <a:xfrm rot="19846348">
            <a:off x="4454651" y="2207174"/>
            <a:ext cx="585157" cy="556744"/>
          </a:xfrm>
          <a:prstGeom prst="ellipse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椭圆 13"/>
          <p:cNvSpPr/>
          <p:nvPr/>
        </p:nvSpPr>
        <p:spPr>
          <a:xfrm rot="19846348">
            <a:off x="4624850" y="2805872"/>
            <a:ext cx="676807" cy="687887"/>
          </a:xfrm>
          <a:prstGeom prst="ellipse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TextBox 14"/>
          <p:cNvSpPr txBox="1"/>
          <p:nvPr/>
        </p:nvSpPr>
        <p:spPr>
          <a:xfrm>
            <a:off x="3419872" y="188640"/>
            <a:ext cx="25202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 </a:t>
            </a:r>
            <a:r>
              <a:rPr lang="en-US" altLang="zh-CN" dirty="0" smtClean="0"/>
              <a:t>4a</a:t>
            </a:r>
            <a:endParaRPr lang="zh-CN" alt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 descr="4.bmp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 rot="10800000">
            <a:off x="1295809" y="800428"/>
            <a:ext cx="6552381" cy="5257143"/>
          </a:xfrm>
          <a:prstGeom prst="rect">
            <a:avLst/>
          </a:prstGeom>
          <a:ln>
            <a:solidFill>
              <a:schemeClr val="tx1"/>
            </a:solidFill>
          </a:ln>
          <a:scene3d>
            <a:camera prst="orthographicFront">
              <a:rot lat="300000" lon="10799999" rev="10799999"/>
            </a:camera>
            <a:lightRig rig="threePt" dir="t"/>
          </a:scene3d>
        </p:spPr>
      </p:pic>
      <p:sp>
        <p:nvSpPr>
          <p:cNvPr id="7" name="TextBox 25"/>
          <p:cNvSpPr txBox="1"/>
          <p:nvPr/>
        </p:nvSpPr>
        <p:spPr>
          <a:xfrm>
            <a:off x="2188514" y="2967119"/>
            <a:ext cx="77859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nLUC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r"/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LUC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26"/>
          <p:cNvSpPr txBox="1"/>
          <p:nvPr/>
        </p:nvSpPr>
        <p:spPr>
          <a:xfrm>
            <a:off x="6690702" y="3966155"/>
            <a:ext cx="138263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nLUC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LUC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ZmGDI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α-hel</a:t>
            </a:r>
          </a:p>
        </p:txBody>
      </p:sp>
      <p:sp>
        <p:nvSpPr>
          <p:cNvPr id="9" name="TextBox 27"/>
          <p:cNvSpPr txBox="1"/>
          <p:nvPr/>
        </p:nvSpPr>
        <p:spPr>
          <a:xfrm>
            <a:off x="1198168" y="3966155"/>
            <a:ext cx="17689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P7-1-nLUC</a:t>
            </a:r>
          </a:p>
          <a:p>
            <a:pPr algn="r"/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LUC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ZmGDI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α-hel</a:t>
            </a:r>
          </a:p>
        </p:txBody>
      </p:sp>
      <p:sp>
        <p:nvSpPr>
          <p:cNvPr id="10" name="TextBox 28"/>
          <p:cNvSpPr txBox="1"/>
          <p:nvPr/>
        </p:nvSpPr>
        <p:spPr>
          <a:xfrm>
            <a:off x="6690702" y="2967119"/>
            <a:ext cx="12241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P7-1-nLUC</a:t>
            </a:r>
          </a:p>
          <a:p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LUC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椭圆 10"/>
          <p:cNvSpPr/>
          <p:nvPr/>
        </p:nvSpPr>
        <p:spPr>
          <a:xfrm rot="1753652" flipV="1">
            <a:off x="3820153" y="2973869"/>
            <a:ext cx="676360" cy="694236"/>
          </a:xfrm>
          <a:prstGeom prst="ellipse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椭圆 11"/>
          <p:cNvSpPr/>
          <p:nvPr/>
        </p:nvSpPr>
        <p:spPr>
          <a:xfrm rot="1753652" flipV="1">
            <a:off x="3248506" y="3680209"/>
            <a:ext cx="1329783" cy="1153768"/>
          </a:xfrm>
          <a:prstGeom prst="ellipse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矩形 12"/>
          <p:cNvSpPr/>
          <p:nvPr/>
        </p:nvSpPr>
        <p:spPr>
          <a:xfrm>
            <a:off x="2915816" y="1628800"/>
            <a:ext cx="3816424" cy="396044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椭圆 13"/>
          <p:cNvSpPr/>
          <p:nvPr/>
        </p:nvSpPr>
        <p:spPr>
          <a:xfrm rot="19846348">
            <a:off x="4935885" y="2856686"/>
            <a:ext cx="828600" cy="856595"/>
          </a:xfrm>
          <a:prstGeom prst="ellipse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椭圆 14"/>
          <p:cNvSpPr/>
          <p:nvPr/>
        </p:nvSpPr>
        <p:spPr>
          <a:xfrm rot="18967073">
            <a:off x="4938114" y="3946265"/>
            <a:ext cx="997752" cy="834974"/>
          </a:xfrm>
          <a:prstGeom prst="ellipse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TextBox 15"/>
          <p:cNvSpPr txBox="1"/>
          <p:nvPr/>
        </p:nvSpPr>
        <p:spPr>
          <a:xfrm>
            <a:off x="2997624" y="359368"/>
            <a:ext cx="25202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Figure  4a</a:t>
            </a:r>
            <a:endParaRPr lang="zh-CN" alt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5</TotalTime>
  <Words>24</Words>
  <Application>Microsoft Office PowerPoint</Application>
  <PresentationFormat>全屏显示(4:3)</PresentationFormat>
  <Paragraphs>22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</vt:lpstr>
      <vt:lpstr>幻灯片 1</vt:lpstr>
      <vt:lpstr>幻灯片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enovo</dc:creator>
  <cp:lastModifiedBy>lenovo</cp:lastModifiedBy>
  <cp:revision>8</cp:revision>
  <dcterms:created xsi:type="dcterms:W3CDTF">2018-12-20T10:23:36Z</dcterms:created>
  <dcterms:modified xsi:type="dcterms:W3CDTF">2019-01-20T13:25:50Z</dcterms:modified>
</cp:coreProperties>
</file>